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6BC7B-B9F5-4B98-9DAD-3FC1E0BB65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496D1E-792A-4D64-B699-9DE3AB5748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5D926-3DD0-4457-B1E8-B9EA630BA8F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E000B-07BA-49FA-9287-A9CB4F5DE9D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E691B-4C30-4857-99D6-A69F33660E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79EB2-4924-40A9-B0B7-CA34C83C18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AC0B42-0C7E-4190-AE73-2EF06B52D6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BA45F2-DED3-497D-9BCF-E2C544F4E2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9365CB-C473-41FF-9C7A-E25BFABDD4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28B2F-2F3C-4357-8832-019897823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13259F-1790-4DE1-A168-C6DC7DBEEF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58E20-7FE3-47E3-9F86-E304A3BB68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8AE6AC-DAA5-4CED-9259-0F29CB7DB6BC}" type="slidenum">
              <a:rPr b="0" lang="ko-KR" sz="1200" spc="-1" strike="noStrike">
                <a:solidFill>
                  <a:srgbClr val="898989"/>
                </a:solidFill>
                <a:latin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6"/>
          <p:cNvSpPr/>
          <p:nvPr/>
        </p:nvSpPr>
        <p:spPr>
          <a:xfrm>
            <a:off x="104760" y="142920"/>
            <a:ext cx="8172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굴림"/>
              </a:rPr>
              <a:t>STable 1. Differentially expressed miRNAs at 48 hr after suppression of JNK signaling in limb mesenchymal cells 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042920" y="476280"/>
          <a:ext cx="5713560" cy="5684760"/>
        </p:xfrm>
        <a:graphic>
          <a:graphicData uri="http://schemas.openxmlformats.org/drawingml/2006/table">
            <a:tbl>
              <a:tblPr/>
              <a:tblGrid>
                <a:gridCol w="1050840"/>
                <a:gridCol w="760680"/>
                <a:gridCol w="2020680"/>
                <a:gridCol w="1881360"/>
              </a:tblGrid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N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Fold chang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human 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hicken sequenc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4000">
                <a:tc gridSpan="4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Up-regula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572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34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.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UGGCAGUGUCUUAGCUGGUUG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UGGCAGUGUCUUAGCUGGUUGU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25a-3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CCCUGAGACCCUUUAACCUG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CUCCAUUUGUUUUGAUGAU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AUCAUCGUCUCAAAUGAGUC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42-3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UAGUGUUUCCUACUUUAU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UAGUGUUUCCUACUUUAU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46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AGAACUGAAUUCCAUGGGU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AGAACUGAAUUCCAUGGGU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93a-5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GGUCUUUGCGGGCGAGA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93b-5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GGGGUUUUGAGGGCGAGA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572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2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GCUACAUUGUCUGCUGGGUUU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4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GCUACAUUGUCUGCUGGGUUU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3572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3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CUCAAAAUGGGGGCGCUUU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AAGUGCUUCGAUUUUGGGGUG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491-3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UUAUGCAAGAUUCCCUUCU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518a-2-3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AAAGCGCUUCCCUUUGCU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671-3p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CCGGUUCUCAGGGCUCC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8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CAGGAACUUGUGAGUCUCC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22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GAGACUGAUGAGUUCCCG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gridSpan="4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Down-regulat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5.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CUUUGGUUAUCUAGCUGUA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CUUUGGUUAUCUAGCUGUA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5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2.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AGCAGCACAUCAUGGUUUA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AGCAGCACAUCAUGGUUUG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3.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AGCUUAUCAGACUGAUGU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AGCUUAUCAGACUGAUGU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GAGUGUGACAAUGGUGUUU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GAGUGUGACAAUGGUGUUUG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72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24-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GUGUUCACAGCGGACCUUGA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　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AAGGCACGCGGUGAAUG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3.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AGUGGUUUUACCCUAUGGU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GUGGUUUUACCCUAUGGU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CUCCAUUUGUUUUGAUGAU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AUCAUCGUCUCAAAUGAGUC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199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2.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CAGUAGUCUGCACAUUGGUU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AGUAGUCUGCACAUUUGGU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3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AUUGCACUUUAGCAAUGGU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AUUGCACUUUAGCAAUGGU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rowSpan="2"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4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3.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CCCAGAUAAUGGCACUCU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UGAAAGGCUAUUUCUUGGU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212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551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-3.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　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CGACCCAUACUUGGUUU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CGACCCAUACUUGGUUU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5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GGCGCCUGUGAUCCC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5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UGAGUUGGCCAUCUGAGUG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62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ACAGUCUGCUGAGGUUGGA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1840"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R-6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 Unicode MS"/>
                        </a:rPr>
                        <a:t>GUGUCUGCUUCCUGUGG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9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　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맑은 고딕"/>
                      </a:endParaRPr>
                    </a:p>
                  </a:txBody>
                  <a:tcPr anchor="ctr" marL="4320" marR="432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9-20T01:52:42Z</dcterms:created>
  <dc:creator>진은정</dc:creator>
  <dc:description/>
  <dc:language>en-US</dc:language>
  <cp:lastModifiedBy>진은정</cp:lastModifiedBy>
  <dcterms:modified xsi:type="dcterms:W3CDTF">2012-09-20T01:53:25Z</dcterms:modified>
  <cp:revision>2</cp:revision>
  <dc:subject/>
  <dc:title>슬라이드 1</dc:title>
</cp:coreProperties>
</file>